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4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B0C250C0-434A-4542-08F9-1CF202FC47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690465" y="3602038"/>
            <a:ext cx="11327363" cy="571856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Forest plot of baseline serum magnesium in relation to refeeding syndrome in acutely ill patients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694C2246-3C04-670B-AABF-556F5CAE1398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962150" y="1169438"/>
            <a:ext cx="8267700" cy="2116688"/>
            <a:chOff x="1236" y="1008"/>
            <a:chExt cx="5208" cy="1062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525E2011-FA6E-403C-A373-AFE4254AEF47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236" y="1008"/>
              <a:ext cx="5208" cy="1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FB4A31EA-2715-2CE7-7EA3-6F16D36023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6" y="1008"/>
              <a:ext cx="5208" cy="1062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69A8D0DA-F486-E66C-53D3-9F211FE72F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6" y="1201"/>
              <a:ext cx="5208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B8E05C55-FDE3-D7E4-D227-FF32402DFF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" y="1128"/>
              <a:ext cx="76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tudy or Sub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7BD8CE45-D3EA-080A-047C-9C3C4508C6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" y="1235"/>
              <a:ext cx="3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an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7A614339-00D5-BD64-C820-B8D6FD4507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" y="1333"/>
              <a:ext cx="324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ing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1C0A63E9-C4D4-8C17-B71A-F58EB34C4A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" y="1428"/>
              <a:ext cx="33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Qiu202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6908142A-A552-E16F-CCE4-EF1B298FD5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" y="1525"/>
              <a:ext cx="37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alib 201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95E72B4F-CB82-8915-2F5A-A6A4B39DBD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" y="1707"/>
              <a:ext cx="563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 (95% CI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65808648-5043-9B15-0D2D-67D4A49AAE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" y="1814"/>
              <a:ext cx="187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terogeneity: Chi² = 0.49, df = 3 (P = 0.92); I² = 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701F6A3C-26CA-AFAD-5DD3-CDFC42295B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" y="1911"/>
              <a:ext cx="135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st for overall effect: Z = 0.61 (P = 0.54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15583021-3045-E7E1-444D-8FEB170F87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9" y="1128"/>
              <a:ext cx="242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594A78E6-DE42-B6A9-2539-CA8EB6644A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5" y="1235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DB20220B-135F-1C46-8E9C-D76F20A2BA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5" y="1333"/>
              <a:ext cx="17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56E352C3-E18C-B849-66CE-732D68C4DB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5" y="1428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B74D64BF-4947-B800-2D85-C5C32D99F0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5" y="1525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7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3115E998-3A0E-2F2E-F8BA-C89CCF71D3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7" y="1128"/>
              <a:ext cx="15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3E57FB67-E469-510F-A876-865D7E17B7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3" y="1235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18C0F027-270B-A6AF-6DD8-560037B95C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3" y="1333"/>
              <a:ext cx="17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86EC6774-D495-C3D9-64DF-DD5F6471C3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3" y="1428"/>
              <a:ext cx="190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1DFEF544-D034-F9CF-C44B-AC4367D9CE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3" y="1525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FC4978C1-5724-3632-D7ED-B52AA7D3F9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3" y="1128"/>
              <a:ext cx="23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59334C85-711A-6C99-D80A-7097FC57B8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2" y="1235"/>
              <a:ext cx="1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DE3EBDA3-D17E-E3EA-F1CD-4501D6207D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2" y="1333"/>
              <a:ext cx="111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3750326D-C0FE-9096-538F-6664FFF14D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1" y="1428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347C8977-7CE1-A42E-DF11-935628ADFB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2" y="1525"/>
              <a:ext cx="1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4E30D538-C647-ADBD-E6DA-A24B2CE6C1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6" y="1707"/>
              <a:ext cx="17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5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ACA4F1B6-917D-AEFC-40C1-5DD0057072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6" y="1128"/>
              <a:ext cx="242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AB6CE263-FBF5-09E3-9100-01446D0A87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2" y="1235"/>
              <a:ext cx="1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0B1C8EEC-B7CE-8584-A89D-D0B073B6BE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2" y="1333"/>
              <a:ext cx="171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54CF4AD5-D7D1-49DB-DB5F-807CCC461C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2" y="1428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51FFAFF7-F893-06C4-32FD-1BBD8B9618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2" y="1525"/>
              <a:ext cx="13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563ABE55-2940-331F-D599-DAD6510505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0" y="1128"/>
              <a:ext cx="149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BBC55438-39C4-4652-F06D-CFE98CAED6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6" y="1235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C9C4E39A-8415-BF6F-08C9-1389E09CF1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6" y="1333"/>
              <a:ext cx="17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CA44C17D-E73D-5367-6956-78A34BBE73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6" y="1428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69834CF3-AFAD-9E4B-CF69-889FEA0F4C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6" y="1525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6C3D68E6-1CAB-4781-FBF2-43C6ECC3F9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2" y="1128"/>
              <a:ext cx="229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64CBA78C-6FBB-69CD-FBFC-987A8222A7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0" y="1235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5D190370-844C-A9FA-3102-3372C33C61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0" y="1333"/>
              <a:ext cx="11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5938ABEB-5946-735E-C72D-0133AE296B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0" y="1428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94FBABB0-F318-AD51-B82E-CA4FFE71FE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0" y="1525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2CE04108-B27E-BC62-4B7E-AB5DAF0473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4" y="1707"/>
              <a:ext cx="17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6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4F1AE420-CE60-75E2-2414-E568108569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1" y="1128"/>
              <a:ext cx="304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C780A10E-551B-FEF9-DC56-4A192AE857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7" y="1235"/>
              <a:ext cx="19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.2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402AF4F3-8FA4-1674-2FEC-BE24CDEBB7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6" y="1333"/>
              <a:ext cx="236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7.4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59406FF4-AFB8-D1E2-4E51-39034DDCFF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6" y="1428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2.7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4AFC7212-F9F9-53B3-9791-D3F7F35A86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6" y="1525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.7%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30D983AB-B327-938F-EB6F-0A72FCFCD7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1" y="1707"/>
              <a:ext cx="304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00.0%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53">
              <a:extLst>
                <a:ext uri="{FF2B5EF4-FFF2-40B4-BE49-F238E27FC236}">
                  <a16:creationId xmlns:a16="http://schemas.microsoft.com/office/drawing/2014/main" id="{D20F9C9E-E722-DC03-361A-D1456CB44C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7" y="1128"/>
              <a:ext cx="667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Fixed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A5FB9A8E-9827-6270-88AF-767D512FDF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9" y="1235"/>
              <a:ext cx="5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02 [-0.12, 0.08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D3B9A6AD-0071-E5DB-D8CC-83EF6F25CB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3" y="1333"/>
              <a:ext cx="575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1 [-0.06, 0.08]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B5723344-65C6-E6BE-F281-DB7A236A1B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9" y="1428"/>
              <a:ext cx="6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01 [-0.05, 0.03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44A867D4-02D7-D76D-5AA3-0693C02C27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9" y="1525"/>
              <a:ext cx="5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03 [-0.12, 0.06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id="{8795A8E8-1506-A892-560F-1D0A5ED33A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5" y="1707"/>
              <a:ext cx="674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-0.01 [-0.04, 0.02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B61F5E26-9723-877E-E9BA-53C88C85C0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1" y="1032"/>
              <a:ext cx="403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BD6D2A1D-9975-D182-34E8-0CD5337966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7" y="1032"/>
              <a:ext cx="558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non-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0C0E7713-FC89-8A4F-3D91-BC50145E5C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0" y="1032"/>
              <a:ext cx="592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93D70794-8F92-2E7E-36F5-21AAB7DA64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95" y="1032"/>
              <a:ext cx="592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id="{53127262-B851-E7BE-FFCA-0FD53B25D1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4" y="1128"/>
              <a:ext cx="668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Fixed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Line 64">
              <a:extLst>
                <a:ext uri="{FF2B5EF4-FFF2-40B4-BE49-F238E27FC236}">
                  <a16:creationId xmlns:a16="http://schemas.microsoft.com/office/drawing/2014/main" id="{1D858BF2-0769-F9C3-D5CF-8DF0D75E33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78" y="1201"/>
              <a:ext cx="0" cy="628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" name="Line 65">
              <a:extLst>
                <a:ext uri="{FF2B5EF4-FFF2-40B4-BE49-F238E27FC236}">
                  <a16:creationId xmlns:a16="http://schemas.microsoft.com/office/drawing/2014/main" id="{C6A7F6FC-686F-2237-297A-697908A5E3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65" y="1249"/>
              <a:ext cx="523" cy="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162DCD7A-FE6C-6D7E-1150-CCB30633D2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6" y="1245"/>
              <a:ext cx="21" cy="21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" name="Line 67">
              <a:extLst>
                <a:ext uri="{FF2B5EF4-FFF2-40B4-BE49-F238E27FC236}">
                  <a16:creationId xmlns:a16="http://schemas.microsoft.com/office/drawing/2014/main" id="{939BE3B0-0569-0070-8288-11D36BCF65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13" y="1346"/>
              <a:ext cx="380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1" name="Rectangle 68">
              <a:extLst>
                <a:ext uri="{FF2B5EF4-FFF2-40B4-BE49-F238E27FC236}">
                  <a16:creationId xmlns:a16="http://schemas.microsoft.com/office/drawing/2014/main" id="{C17A10FA-7718-60FB-856A-41E3110682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9" y="1337"/>
              <a:ext cx="29" cy="29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2" name="Line 69">
              <a:extLst>
                <a:ext uri="{FF2B5EF4-FFF2-40B4-BE49-F238E27FC236}">
                  <a16:creationId xmlns:a16="http://schemas.microsoft.com/office/drawing/2014/main" id="{D69EEF5E-5C1A-6909-6FBA-5B24A7CF04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52" y="1442"/>
              <a:ext cx="200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3" name="Rectangle 70">
              <a:extLst>
                <a:ext uri="{FF2B5EF4-FFF2-40B4-BE49-F238E27FC236}">
                  <a16:creationId xmlns:a16="http://schemas.microsoft.com/office/drawing/2014/main" id="{D21EB7A6-F881-DF97-F2DC-87ADB6CB16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6" y="1412"/>
              <a:ext cx="72" cy="73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4" name="Line 71">
              <a:extLst>
                <a:ext uri="{FF2B5EF4-FFF2-40B4-BE49-F238E27FC236}">
                  <a16:creationId xmlns:a16="http://schemas.microsoft.com/office/drawing/2014/main" id="{7784522F-4CFF-414E-5505-2A379209EB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58" y="1539"/>
              <a:ext cx="486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5" name="Rectangle 72">
              <a:extLst>
                <a:ext uri="{FF2B5EF4-FFF2-40B4-BE49-F238E27FC236}">
                  <a16:creationId xmlns:a16="http://schemas.microsoft.com/office/drawing/2014/main" id="{211C8682-EDB7-C95E-0BB5-1A53053854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90" y="1534"/>
              <a:ext cx="22" cy="22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6" name="Freeform 73">
              <a:extLst>
                <a:ext uri="{FF2B5EF4-FFF2-40B4-BE49-F238E27FC236}">
                  <a16:creationId xmlns:a16="http://schemas.microsoft.com/office/drawing/2014/main" id="{A97F083B-4117-1730-3A07-078045F65A3F}"/>
                </a:ext>
              </a:extLst>
            </p:cNvPr>
            <p:cNvSpPr>
              <a:spLocks/>
            </p:cNvSpPr>
            <p:nvPr/>
          </p:nvSpPr>
          <p:spPr bwMode="auto">
            <a:xfrm>
              <a:off x="5273" y="1690"/>
              <a:ext cx="156" cy="84"/>
            </a:xfrm>
            <a:custGeom>
              <a:avLst/>
              <a:gdLst>
                <a:gd name="T0" fmla="*/ 260 w 520"/>
                <a:gd name="T1" fmla="*/ 280 h 280"/>
                <a:gd name="T2" fmla="*/ 0 w 520"/>
                <a:gd name="T3" fmla="*/ 140 h 280"/>
                <a:gd name="T4" fmla="*/ 260 w 520"/>
                <a:gd name="T5" fmla="*/ 0 h 280"/>
                <a:gd name="T6" fmla="*/ 520 w 520"/>
                <a:gd name="T7" fmla="*/ 140 h 280"/>
                <a:gd name="T8" fmla="*/ 260 w 52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20" h="280">
                  <a:moveTo>
                    <a:pt x="260" y="280"/>
                  </a:moveTo>
                  <a:lnTo>
                    <a:pt x="0" y="140"/>
                  </a:lnTo>
                  <a:lnTo>
                    <a:pt x="260" y="0"/>
                  </a:lnTo>
                  <a:lnTo>
                    <a:pt x="520" y="140"/>
                  </a:lnTo>
                  <a:lnTo>
                    <a:pt x="260" y="280"/>
                  </a:lnTo>
                  <a:close/>
                </a:path>
              </a:pathLst>
            </a:custGeom>
            <a:solidFill>
              <a:srgbClr val="000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7" name="Line 74">
              <a:extLst>
                <a:ext uri="{FF2B5EF4-FFF2-40B4-BE49-F238E27FC236}">
                  <a16:creationId xmlns:a16="http://schemas.microsoft.com/office/drawing/2014/main" id="{E1D2A932-EAC7-DEE4-DFB7-4CD73292CD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78" y="1829"/>
              <a:ext cx="2000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8" name="Line 75">
              <a:extLst>
                <a:ext uri="{FF2B5EF4-FFF2-40B4-BE49-F238E27FC236}">
                  <a16:creationId xmlns:a16="http://schemas.microsoft.com/office/drawing/2014/main" id="{46D0F401-5158-0FE9-808B-1F774DAFE4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65" y="180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9" name="Rectangle 76">
              <a:extLst>
                <a:ext uri="{FF2B5EF4-FFF2-40B4-BE49-F238E27FC236}">
                  <a16:creationId xmlns:a16="http://schemas.microsoft.com/office/drawing/2014/main" id="{0507F07B-698E-9922-4503-7F06DDBCE4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03" y="1864"/>
              <a:ext cx="156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Line 77">
              <a:extLst>
                <a:ext uri="{FF2B5EF4-FFF2-40B4-BE49-F238E27FC236}">
                  <a16:creationId xmlns:a16="http://schemas.microsoft.com/office/drawing/2014/main" id="{A140B6E7-22FF-1B9D-DE3C-D4FBB1C005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21" y="180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1" name="Rectangle 78">
              <a:extLst>
                <a:ext uri="{FF2B5EF4-FFF2-40B4-BE49-F238E27FC236}">
                  <a16:creationId xmlns:a16="http://schemas.microsoft.com/office/drawing/2014/main" id="{C17A310D-B56D-9407-445E-4ED5C7EB5C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9" y="1864"/>
              <a:ext cx="156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Line 79">
              <a:extLst>
                <a:ext uri="{FF2B5EF4-FFF2-40B4-BE49-F238E27FC236}">
                  <a16:creationId xmlns:a16="http://schemas.microsoft.com/office/drawing/2014/main" id="{BEB8E3CB-E476-AD02-B283-41B4A87C81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78" y="180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3" name="Rectangle 80">
              <a:extLst>
                <a:ext uri="{FF2B5EF4-FFF2-40B4-BE49-F238E27FC236}">
                  <a16:creationId xmlns:a16="http://schemas.microsoft.com/office/drawing/2014/main" id="{048B9BEE-46C1-CD54-C871-5513DA162E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58" y="1864"/>
              <a:ext cx="7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Line 81">
              <a:extLst>
                <a:ext uri="{FF2B5EF4-FFF2-40B4-BE49-F238E27FC236}">
                  <a16:creationId xmlns:a16="http://schemas.microsoft.com/office/drawing/2014/main" id="{1D9D8340-0972-21E9-98C5-6998CB7BC8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34" y="180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5" name="Rectangle 82">
              <a:extLst>
                <a:ext uri="{FF2B5EF4-FFF2-40B4-BE49-F238E27FC236}">
                  <a16:creationId xmlns:a16="http://schemas.microsoft.com/office/drawing/2014/main" id="{7C07FB19-876C-1DDF-0781-F1012B84E8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4" y="1864"/>
              <a:ext cx="13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Line 83">
              <a:extLst>
                <a:ext uri="{FF2B5EF4-FFF2-40B4-BE49-F238E27FC236}">
                  <a16:creationId xmlns:a16="http://schemas.microsoft.com/office/drawing/2014/main" id="{FFB3AF2A-9143-6ADA-4473-337E8722B0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90" y="180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7" name="Rectangle 84">
              <a:extLst>
                <a:ext uri="{FF2B5EF4-FFF2-40B4-BE49-F238E27FC236}">
                  <a16:creationId xmlns:a16="http://schemas.microsoft.com/office/drawing/2014/main" id="{E2E46103-7E34-1489-572D-49B1251EBB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1" y="1864"/>
              <a:ext cx="131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85">
              <a:extLst>
                <a:ext uri="{FF2B5EF4-FFF2-40B4-BE49-F238E27FC236}">
                  <a16:creationId xmlns:a16="http://schemas.microsoft.com/office/drawing/2014/main" id="{EE035F12-1495-8817-194F-AD530C67AE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5" y="1951"/>
              <a:ext cx="70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86">
              <a:extLst>
                <a:ext uri="{FF2B5EF4-FFF2-40B4-BE49-F238E27FC236}">
                  <a16:creationId xmlns:a16="http://schemas.microsoft.com/office/drawing/2014/main" id="{037E1543-26CE-20D3-6A96-E9241659BF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08" y="1951"/>
              <a:ext cx="84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non-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37797660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7</Words>
  <Application>Microsoft Office PowerPoint</Application>
  <PresentationFormat>宽屏</PresentationFormat>
  <Paragraphs>6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吴轩乐</dc:creator>
  <cp:lastModifiedBy>轩乐 吴</cp:lastModifiedBy>
  <cp:revision>6</cp:revision>
  <dcterms:created xsi:type="dcterms:W3CDTF">2023-08-09T12:44:00Z</dcterms:created>
  <dcterms:modified xsi:type="dcterms:W3CDTF">2026-02-06T15:58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